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14">
          <p15:clr>
            <a:srgbClr val="A4A3A4"/>
          </p15:clr>
        </p15:guide>
        <p15:guide id="2" pos="1380">
          <p15:clr>
            <a:srgbClr val="A4A3A4"/>
          </p15:clr>
        </p15:guide>
        <p15:guide id="3" pos="158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134" y="90"/>
      </p:cViewPr>
      <p:guideLst>
        <p:guide orient="horz" pos="2314"/>
        <p:guide pos="1380"/>
        <p:guide pos="158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57CC34-D0D7-4115-9933-90AC4C724EFB}" type="datetimeFigureOut">
              <a:rPr lang="da-DK" smtClean="0"/>
              <a:t>01-07-2015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7156B4-B2EA-499B-87A2-129BAB151AF1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25944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7156B4-B2EA-499B-87A2-129BAB151AF1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0826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2" t="25645"/>
          <a:stretch/>
        </p:blipFill>
        <p:spPr bwMode="auto">
          <a:xfrm>
            <a:off x="610888" y="1197340"/>
            <a:ext cx="3804249" cy="17470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278531" y="3429000"/>
            <a:ext cx="8922827" cy="310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thern blot analysis of the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after CRISPR-Cas9 mediated gen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ing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 panels, two configurations of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us after gene targeting. Top left panel,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us after insertion of the gene-targeting substrate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 left panel,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us after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L_pyr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 has been eliminated by direct-repeat recombina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result of a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h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oI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uble digest is shown. The positions of the probe used for Southern blotting are indicated by a fat black line. DR indicates the position of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irect repeat sequences that flank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L_pyr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 panel, Southern blot of genomic DNA digested wit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h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Lanes 1 and 2 contain DNA from two independent yellow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ormants before exposure to 5-FOA (is expected to contain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L_pyr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 at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lanes 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conta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nies that have been exposed to 5-FOA (i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cted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ve lost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L_pyr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leaving a single repeat at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)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5 contains DNA from the reference strain (contains no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L_pyr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)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ic DNA was isolated and digested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h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o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eparated on a 1% agarose gel, and transferred  to a nylon membrane using 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atma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metr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cu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Blot System and fixed by UV-irradiation. Visualization was made by the Biot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aLabe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NA labeling-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iotin Chromogenic Detection kits using manufacturers instructions (Life Technologies). The probe was generated by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 JBNA353 and JBNA354 (se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) using vector pU2002c (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ocol) as template.</a:t>
            </a:r>
            <a:endParaRPr lang="da-DK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4642420" y="468868"/>
            <a:ext cx="3968180" cy="2807732"/>
            <a:chOff x="990600" y="1002268"/>
            <a:chExt cx="3968180" cy="2807732"/>
          </a:xfrm>
        </p:grpSpPr>
        <p:pic>
          <p:nvPicPr>
            <p:cNvPr id="46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72" t="11433" r="55815" b="2857"/>
            <a:stretch/>
          </p:blipFill>
          <p:spPr bwMode="auto">
            <a:xfrm>
              <a:off x="2947388" y="1345722"/>
              <a:ext cx="944592" cy="24585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0" name="Group 49"/>
            <p:cNvGrpSpPr/>
            <p:nvPr/>
          </p:nvGrpSpPr>
          <p:grpSpPr>
            <a:xfrm>
              <a:off x="990600" y="2169979"/>
              <a:ext cx="949315" cy="307777"/>
              <a:chOff x="38410" y="2152727"/>
              <a:chExt cx="949315" cy="307777"/>
            </a:xfrm>
          </p:grpSpPr>
          <p:cxnSp>
            <p:nvCxnSpPr>
              <p:cNvPr id="89" name="Straight Arrow Connector 88"/>
              <p:cNvCxnSpPr/>
              <p:nvPr/>
            </p:nvCxnSpPr>
            <p:spPr>
              <a:xfrm>
                <a:off x="685800" y="2306615"/>
                <a:ext cx="30192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38410" y="2152727"/>
                <a:ext cx="628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dirty="0" smtClean="0"/>
                  <a:t>3.0 kb</a:t>
                </a:r>
                <a:endParaRPr lang="da-DK" sz="1400" dirty="0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990600" y="2443252"/>
              <a:ext cx="949315" cy="307777"/>
              <a:chOff x="38410" y="2460504"/>
              <a:chExt cx="949315" cy="307777"/>
            </a:xfrm>
          </p:grpSpPr>
          <p:sp>
            <p:nvSpPr>
              <p:cNvPr id="87" name="TextBox 86"/>
              <p:cNvSpPr txBox="1"/>
              <p:nvPr/>
            </p:nvSpPr>
            <p:spPr>
              <a:xfrm>
                <a:off x="38410" y="2460504"/>
                <a:ext cx="628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dirty="0"/>
                  <a:t>2</a:t>
                </a:r>
                <a:r>
                  <a:rPr lang="da-DK" sz="1400" dirty="0" smtClean="0"/>
                  <a:t>.0 kb</a:t>
                </a:r>
                <a:endParaRPr lang="da-DK" sz="1400" dirty="0"/>
              </a:p>
            </p:txBody>
          </p:sp>
          <p:cxnSp>
            <p:nvCxnSpPr>
              <p:cNvPr id="88" name="Straight Arrow Connector 87"/>
              <p:cNvCxnSpPr/>
              <p:nvPr/>
            </p:nvCxnSpPr>
            <p:spPr>
              <a:xfrm>
                <a:off x="685800" y="2614392"/>
                <a:ext cx="30192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/>
            <p:cNvGrpSpPr/>
            <p:nvPr/>
          </p:nvGrpSpPr>
          <p:grpSpPr>
            <a:xfrm>
              <a:off x="990600" y="2988858"/>
              <a:ext cx="949315" cy="307777"/>
              <a:chOff x="38410" y="2980232"/>
              <a:chExt cx="949315" cy="307777"/>
            </a:xfrm>
          </p:grpSpPr>
          <p:sp>
            <p:nvSpPr>
              <p:cNvPr id="85" name="TextBox 84"/>
              <p:cNvSpPr txBox="1"/>
              <p:nvPr/>
            </p:nvSpPr>
            <p:spPr>
              <a:xfrm>
                <a:off x="38410" y="2980232"/>
                <a:ext cx="628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dirty="0" smtClean="0"/>
                  <a:t>1.0 kb</a:t>
                </a:r>
                <a:endParaRPr lang="da-DK" sz="1400" dirty="0"/>
              </a:p>
            </p:txBody>
          </p:sp>
          <p:cxnSp>
            <p:nvCxnSpPr>
              <p:cNvPr id="86" name="Straight Arrow Connector 85"/>
              <p:cNvCxnSpPr/>
              <p:nvPr/>
            </p:nvCxnSpPr>
            <p:spPr>
              <a:xfrm>
                <a:off x="685800" y="3134120"/>
                <a:ext cx="30192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7" name="Group 56"/>
            <p:cNvGrpSpPr/>
            <p:nvPr/>
          </p:nvGrpSpPr>
          <p:grpSpPr>
            <a:xfrm>
              <a:off x="990600" y="1793369"/>
              <a:ext cx="949315" cy="307777"/>
              <a:chOff x="38410" y="1793369"/>
              <a:chExt cx="949315" cy="307777"/>
            </a:xfrm>
          </p:grpSpPr>
          <p:cxnSp>
            <p:nvCxnSpPr>
              <p:cNvPr id="83" name="Straight Arrow Connector 82"/>
              <p:cNvCxnSpPr/>
              <p:nvPr/>
            </p:nvCxnSpPr>
            <p:spPr>
              <a:xfrm>
                <a:off x="685800" y="1947257"/>
                <a:ext cx="30192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/>
              <p:cNvSpPr txBox="1"/>
              <p:nvPr/>
            </p:nvSpPr>
            <p:spPr>
              <a:xfrm>
                <a:off x="38410" y="1793369"/>
                <a:ext cx="628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dirty="0"/>
                  <a:t>6</a:t>
                </a:r>
                <a:r>
                  <a:rPr lang="da-DK" sz="1400" dirty="0" smtClean="0"/>
                  <a:t>.0 kb</a:t>
                </a:r>
                <a:endParaRPr lang="da-DK" sz="1400" dirty="0"/>
              </a:p>
            </p:txBody>
          </p:sp>
        </p:grpSp>
        <p:grpSp>
          <p:nvGrpSpPr>
            <p:cNvPr id="58" name="Group 57"/>
            <p:cNvGrpSpPr/>
            <p:nvPr/>
          </p:nvGrpSpPr>
          <p:grpSpPr>
            <a:xfrm>
              <a:off x="990600" y="2674137"/>
              <a:ext cx="949315" cy="307777"/>
              <a:chOff x="38410" y="2665511"/>
              <a:chExt cx="949315" cy="307777"/>
            </a:xfrm>
          </p:grpSpPr>
          <p:cxnSp>
            <p:nvCxnSpPr>
              <p:cNvPr id="81" name="Straight Arrow Connector 80"/>
              <p:cNvCxnSpPr/>
              <p:nvPr/>
            </p:nvCxnSpPr>
            <p:spPr>
              <a:xfrm>
                <a:off x="685800" y="2819399"/>
                <a:ext cx="30192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/>
              <p:cNvSpPr txBox="1"/>
              <p:nvPr/>
            </p:nvSpPr>
            <p:spPr>
              <a:xfrm>
                <a:off x="38410" y="2665511"/>
                <a:ext cx="628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dirty="0" smtClean="0"/>
                  <a:t>1.5 kb</a:t>
                </a:r>
                <a:endParaRPr lang="da-DK" sz="1400" dirty="0"/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2139380" y="1344613"/>
              <a:ext cx="2819400" cy="2465387"/>
              <a:chOff x="4203943" y="1344613"/>
              <a:chExt cx="2819400" cy="2465387"/>
            </a:xfrm>
          </p:grpSpPr>
          <p:grpSp>
            <p:nvGrpSpPr>
              <p:cNvPr id="65" name="Group 64"/>
              <p:cNvGrpSpPr/>
              <p:nvPr/>
            </p:nvGrpSpPr>
            <p:grpSpPr>
              <a:xfrm>
                <a:off x="6035618" y="2236119"/>
                <a:ext cx="987725" cy="307777"/>
                <a:chOff x="4422475" y="2322379"/>
                <a:chExt cx="987725" cy="307777"/>
              </a:xfrm>
            </p:grpSpPr>
            <p:cxnSp>
              <p:nvCxnSpPr>
                <p:cNvPr id="79" name="Straight Arrow Connector 78"/>
                <p:cNvCxnSpPr/>
                <p:nvPr/>
              </p:nvCxnSpPr>
              <p:spPr>
                <a:xfrm>
                  <a:off x="4422475" y="2476267"/>
                  <a:ext cx="30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TextBox 79"/>
                <p:cNvSpPr txBox="1"/>
                <p:nvPr/>
              </p:nvSpPr>
              <p:spPr>
                <a:xfrm>
                  <a:off x="4781502" y="2322379"/>
                  <a:ext cx="6286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a-DK" sz="1400" dirty="0" smtClean="0"/>
                    <a:t>3.0 kb</a:t>
                  </a:r>
                  <a:endParaRPr lang="da-DK" sz="1400" dirty="0"/>
                </a:p>
              </p:txBody>
            </p:sp>
          </p:grpSp>
          <p:grpSp>
            <p:nvGrpSpPr>
              <p:cNvPr id="66" name="Group 65"/>
              <p:cNvGrpSpPr/>
              <p:nvPr/>
            </p:nvGrpSpPr>
            <p:grpSpPr>
              <a:xfrm>
                <a:off x="6035618" y="2500766"/>
                <a:ext cx="987725" cy="307777"/>
                <a:chOff x="4422475" y="2595652"/>
                <a:chExt cx="987725" cy="307777"/>
              </a:xfrm>
            </p:grpSpPr>
            <p:sp>
              <p:nvSpPr>
                <p:cNvPr id="77" name="TextBox 76"/>
                <p:cNvSpPr txBox="1"/>
                <p:nvPr/>
              </p:nvSpPr>
              <p:spPr>
                <a:xfrm>
                  <a:off x="4781502" y="2595652"/>
                  <a:ext cx="6286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a-DK" sz="1400" dirty="0"/>
                    <a:t>2</a:t>
                  </a:r>
                  <a:r>
                    <a:rPr lang="da-DK" sz="1400" dirty="0" smtClean="0"/>
                    <a:t>.0 kb</a:t>
                  </a:r>
                  <a:endParaRPr lang="da-DK" sz="1400" dirty="0"/>
                </a:p>
              </p:txBody>
            </p:sp>
            <p:cxnSp>
              <p:nvCxnSpPr>
                <p:cNvPr id="78" name="Straight Arrow Connector 77"/>
                <p:cNvCxnSpPr/>
                <p:nvPr/>
              </p:nvCxnSpPr>
              <p:spPr>
                <a:xfrm>
                  <a:off x="4422475" y="2749540"/>
                  <a:ext cx="30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7" name="Group 66"/>
              <p:cNvGrpSpPr/>
              <p:nvPr/>
            </p:nvGrpSpPr>
            <p:grpSpPr>
              <a:xfrm>
                <a:off x="6035618" y="3037746"/>
                <a:ext cx="987725" cy="307777"/>
                <a:chOff x="4422475" y="3141258"/>
                <a:chExt cx="987725" cy="307777"/>
              </a:xfrm>
            </p:grpSpPr>
            <p:sp>
              <p:nvSpPr>
                <p:cNvPr id="75" name="TextBox 74"/>
                <p:cNvSpPr txBox="1"/>
                <p:nvPr/>
              </p:nvSpPr>
              <p:spPr>
                <a:xfrm>
                  <a:off x="4781502" y="3141258"/>
                  <a:ext cx="6286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a-DK" sz="1400" dirty="0" smtClean="0"/>
                    <a:t>1.0 kb</a:t>
                  </a:r>
                  <a:endParaRPr lang="da-DK" sz="1400" dirty="0"/>
                </a:p>
              </p:txBody>
            </p:sp>
            <p:cxnSp>
              <p:nvCxnSpPr>
                <p:cNvPr id="76" name="Straight Arrow Connector 75"/>
                <p:cNvCxnSpPr/>
                <p:nvPr/>
              </p:nvCxnSpPr>
              <p:spPr>
                <a:xfrm>
                  <a:off x="4422475" y="3295146"/>
                  <a:ext cx="30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8" name="Group 67"/>
              <p:cNvGrpSpPr/>
              <p:nvPr/>
            </p:nvGrpSpPr>
            <p:grpSpPr>
              <a:xfrm>
                <a:off x="6035618" y="1859509"/>
                <a:ext cx="987725" cy="307777"/>
                <a:chOff x="4422475" y="1945769"/>
                <a:chExt cx="987725" cy="307777"/>
              </a:xfrm>
            </p:grpSpPr>
            <p:cxnSp>
              <p:nvCxnSpPr>
                <p:cNvPr id="73" name="Straight Arrow Connector 72"/>
                <p:cNvCxnSpPr/>
                <p:nvPr/>
              </p:nvCxnSpPr>
              <p:spPr>
                <a:xfrm>
                  <a:off x="4422475" y="2099657"/>
                  <a:ext cx="30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>
                  <a:off x="4781502" y="1945769"/>
                  <a:ext cx="6286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a-DK" sz="1400" dirty="0"/>
                    <a:t>6</a:t>
                  </a:r>
                  <a:r>
                    <a:rPr lang="da-DK" sz="1400" dirty="0" smtClean="0"/>
                    <a:t>.0 kb</a:t>
                  </a:r>
                  <a:endParaRPr lang="da-DK" sz="1400" dirty="0"/>
                </a:p>
              </p:txBody>
            </p:sp>
          </p:grpSp>
          <p:grpSp>
            <p:nvGrpSpPr>
              <p:cNvPr id="69" name="Group 68"/>
              <p:cNvGrpSpPr/>
              <p:nvPr/>
            </p:nvGrpSpPr>
            <p:grpSpPr>
              <a:xfrm>
                <a:off x="6035618" y="2723025"/>
                <a:ext cx="987725" cy="307777"/>
                <a:chOff x="4422475" y="2826537"/>
                <a:chExt cx="987725" cy="307777"/>
              </a:xfrm>
            </p:grpSpPr>
            <p:cxnSp>
              <p:nvCxnSpPr>
                <p:cNvPr id="71" name="Straight Arrow Connector 70"/>
                <p:cNvCxnSpPr/>
                <p:nvPr/>
              </p:nvCxnSpPr>
              <p:spPr>
                <a:xfrm>
                  <a:off x="4422475" y="2980425"/>
                  <a:ext cx="30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TextBox 71"/>
                <p:cNvSpPr txBox="1"/>
                <p:nvPr/>
              </p:nvSpPr>
              <p:spPr>
                <a:xfrm>
                  <a:off x="4781502" y="2826537"/>
                  <a:ext cx="6286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a-DK" sz="1400" dirty="0" smtClean="0"/>
                    <a:t>1.5 kb</a:t>
                  </a:r>
                  <a:endParaRPr lang="da-DK" sz="1400" dirty="0"/>
                </a:p>
              </p:txBody>
            </p:sp>
          </p:grpSp>
          <p:pic>
            <p:nvPicPr>
              <p:cNvPr id="70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267" t="11394" r="10465" b="2656"/>
              <a:stretch/>
            </p:blipFill>
            <p:spPr bwMode="auto">
              <a:xfrm>
                <a:off x="4203943" y="1344613"/>
                <a:ext cx="672860" cy="24653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0" name="TextBox 59"/>
            <p:cNvSpPr txBox="1"/>
            <p:nvPr/>
          </p:nvSpPr>
          <p:spPr>
            <a:xfrm>
              <a:off x="2139380" y="10022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a-DK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512274" y="10022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da-DK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977580" y="10022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da-DK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274274" y="10022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da-DK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579074" y="10022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da-DK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33197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5</TotalTime>
  <Words>42</Words>
  <Application>Microsoft Office PowerPoint</Application>
  <PresentationFormat>Skærm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æ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Engelhard Kogle</dc:creator>
  <cp:lastModifiedBy>Cirenya</cp:lastModifiedBy>
  <cp:revision>46</cp:revision>
  <dcterms:created xsi:type="dcterms:W3CDTF">2006-08-16T00:00:00Z</dcterms:created>
  <dcterms:modified xsi:type="dcterms:W3CDTF">2015-07-01T11:55:44Z</dcterms:modified>
</cp:coreProperties>
</file>